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68" d="100"/>
          <a:sy n="68" d="100"/>
        </p:scale>
        <p:origin x="-1336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2013:RTPCR2013:130425PTPinhibitor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rFig!$C$2</c:f>
              <c:strCache>
                <c:ptCount val="1"/>
                <c:pt idx="0">
                  <c:v>WRKY45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aw!$E$3:$E$26</c:f>
                <c:numCache>
                  <c:formatCode>General</c:formatCode>
                  <c:ptCount val="24"/>
                  <c:pt idx="0">
                    <c:v>0.000258883</c:v>
                  </c:pt>
                  <c:pt idx="1">
                    <c:v>0.05019264</c:v>
                  </c:pt>
                  <c:pt idx="2">
                    <c:v>0.03050405</c:v>
                  </c:pt>
                  <c:pt idx="3">
                    <c:v>0.02266423</c:v>
                  </c:pt>
                  <c:pt idx="4">
                    <c:v>0.006900392</c:v>
                  </c:pt>
                  <c:pt idx="5">
                    <c:v>0.006400816</c:v>
                  </c:pt>
                  <c:pt idx="6">
                    <c:v>0.01747874</c:v>
                  </c:pt>
                  <c:pt idx="7">
                    <c:v>0.006430842</c:v>
                  </c:pt>
                  <c:pt idx="8">
                    <c:v>0.002135376</c:v>
                  </c:pt>
                  <c:pt idx="9">
                    <c:v>0.06371789</c:v>
                  </c:pt>
                  <c:pt idx="10">
                    <c:v>0.03521885</c:v>
                  </c:pt>
                  <c:pt idx="11">
                    <c:v>0.06822892</c:v>
                  </c:pt>
                  <c:pt idx="12">
                    <c:v>0.07877107</c:v>
                  </c:pt>
                  <c:pt idx="13">
                    <c:v>0.01834155</c:v>
                  </c:pt>
                  <c:pt idx="14">
                    <c:v>0.03092374</c:v>
                  </c:pt>
                  <c:pt idx="15">
                    <c:v>0.008792855</c:v>
                  </c:pt>
                  <c:pt idx="16">
                    <c:v>0.009160042</c:v>
                  </c:pt>
                  <c:pt idx="17">
                    <c:v>0.03583723</c:v>
                  </c:pt>
                  <c:pt idx="18">
                    <c:v>0.165694</c:v>
                  </c:pt>
                  <c:pt idx="19">
                    <c:v>0.005491853</c:v>
                  </c:pt>
                  <c:pt idx="20">
                    <c:v>0.04423368</c:v>
                  </c:pt>
                  <c:pt idx="21">
                    <c:v>0.006377339</c:v>
                  </c:pt>
                  <c:pt idx="22">
                    <c:v>0.04069307</c:v>
                  </c:pt>
                  <c:pt idx="23">
                    <c:v>0.04656126</c:v>
                  </c:pt>
                </c:numCache>
              </c:numRef>
            </c:plus>
            <c:minus>
              <c:numRef>
                <c:f>Raw!$D$3:$D$26</c:f>
                <c:numCache>
                  <c:formatCode>General</c:formatCode>
                  <c:ptCount val="24"/>
                  <c:pt idx="0">
                    <c:v>0.0002501509</c:v>
                  </c:pt>
                  <c:pt idx="1">
                    <c:v>0.0385752</c:v>
                  </c:pt>
                  <c:pt idx="2">
                    <c:v>0.02398662</c:v>
                  </c:pt>
                  <c:pt idx="3">
                    <c:v>0.01852828</c:v>
                  </c:pt>
                  <c:pt idx="4">
                    <c:v>0.006334312</c:v>
                  </c:pt>
                  <c:pt idx="5">
                    <c:v>0.005840771</c:v>
                  </c:pt>
                  <c:pt idx="6">
                    <c:v>0.01450852</c:v>
                  </c:pt>
                  <c:pt idx="7">
                    <c:v>0.005978927</c:v>
                  </c:pt>
                  <c:pt idx="8">
                    <c:v>0.00188636</c:v>
                  </c:pt>
                  <c:pt idx="9">
                    <c:v>0.04997227</c:v>
                  </c:pt>
                  <c:pt idx="10">
                    <c:v>0.02893291</c:v>
                  </c:pt>
                  <c:pt idx="11">
                    <c:v>0.04993302</c:v>
                  </c:pt>
                  <c:pt idx="12">
                    <c:v>0.05360857</c:v>
                  </c:pt>
                  <c:pt idx="13">
                    <c:v>0.01569597</c:v>
                  </c:pt>
                  <c:pt idx="14">
                    <c:v>0.0262513</c:v>
                  </c:pt>
                  <c:pt idx="15">
                    <c:v>0.008160338</c:v>
                  </c:pt>
                  <c:pt idx="16">
                    <c:v>0.008264132</c:v>
                  </c:pt>
                  <c:pt idx="17">
                    <c:v>0.0343675</c:v>
                  </c:pt>
                  <c:pt idx="18">
                    <c:v>0.1262501</c:v>
                  </c:pt>
                  <c:pt idx="19">
                    <c:v>0.00538522</c:v>
                  </c:pt>
                  <c:pt idx="20">
                    <c:v>0.03590822</c:v>
                  </c:pt>
                  <c:pt idx="21">
                    <c:v>0.006070815</c:v>
                  </c:pt>
                  <c:pt idx="22">
                    <c:v>0.0317556</c:v>
                  </c:pt>
                  <c:pt idx="23">
                    <c:v>0.03504014</c:v>
                  </c:pt>
                </c:numCache>
              </c:numRef>
            </c:minus>
          </c:errBars>
          <c:cat>
            <c:strRef>
              <c:f>forFig!$B$3:$B$10</c:f>
              <c:strCache>
                <c:ptCount val="8"/>
                <c:pt idx="0">
                  <c:v>mock</c:v>
                </c:pt>
                <c:pt idx="1">
                  <c:v>SA</c:v>
                </c:pt>
                <c:pt idx="2">
                  <c:v>SA+30ABA (-1h)</c:v>
                </c:pt>
                <c:pt idx="3">
                  <c:v>SA+100ABA (-1h)</c:v>
                </c:pt>
                <c:pt idx="4">
                  <c:v>SA+30ABA (-1h)+50Bay</c:v>
                </c:pt>
                <c:pt idx="5">
                  <c:v>SA+100ABA (-1h)+50Bay</c:v>
                </c:pt>
                <c:pt idx="6">
                  <c:v>SA+30ABA (-1h)+2Vana</c:v>
                </c:pt>
                <c:pt idx="7">
                  <c:v>SA+100ABA (-1h)+2Vana</c:v>
                </c:pt>
              </c:strCache>
            </c:strRef>
          </c:cat>
          <c:val>
            <c:numRef>
              <c:f>forFig!$C$3:$C$10</c:f>
              <c:numCache>
                <c:formatCode>General</c:formatCode>
                <c:ptCount val="8"/>
                <c:pt idx="0">
                  <c:v>0.007416741</c:v>
                </c:pt>
                <c:pt idx="1">
                  <c:v>0.1666624</c:v>
                </c:pt>
                <c:pt idx="2">
                  <c:v>0.07721368</c:v>
                </c:pt>
                <c:pt idx="3">
                  <c:v>0.06675406</c:v>
                </c:pt>
                <c:pt idx="4">
                  <c:v>0.1678215</c:v>
                </c:pt>
                <c:pt idx="5">
                  <c:v>0.1088188</c:v>
                </c:pt>
                <c:pt idx="6">
                  <c:v>0.1907825</c:v>
                </c:pt>
                <c:pt idx="7">
                  <c:v>0.12630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06033832"/>
        <c:axId val="-2126104664"/>
      </c:barChart>
      <c:catAx>
        <c:axId val="-210603383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2126104664"/>
        <c:crossesAt val="0.0"/>
        <c:auto val="1"/>
        <c:lblAlgn val="ctr"/>
        <c:lblOffset val="100"/>
        <c:noMultiLvlLbl val="0"/>
      </c:catAx>
      <c:valAx>
        <c:axId val="-2126104664"/>
        <c:scaling>
          <c:orientation val="minMax"/>
          <c:max val="0.25"/>
          <c:min val="0.0"/>
        </c:scaling>
        <c:delete val="0"/>
        <c:axPos val="l"/>
        <c:majorGridlines>
          <c:spPr>
            <a:ln>
              <a:solidFill>
                <a:schemeClr val="bg1">
                  <a:lumMod val="50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 b="1" i="0">
                <a:latin typeface="Helvetica"/>
                <a:cs typeface="Helvetica"/>
              </a:defRPr>
            </a:pPr>
            <a:endParaRPr lang="ja-JP"/>
          </a:p>
        </c:txPr>
        <c:crossAx val="-2106033832"/>
        <c:crosses val="autoZero"/>
        <c:crossBetween val="between"/>
        <c:majorUnit val="0.05"/>
        <c:minorUnit val="0.05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1096968383"/>
              </p:ext>
            </p:extLst>
          </p:nvPr>
        </p:nvGraphicFramePr>
        <p:xfrm>
          <a:off x="2101832" y="3068826"/>
          <a:ext cx="2586995" cy="17029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>
            <a:off x="3318787" y="2860741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*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grpSp>
        <p:nvGrpSpPr>
          <p:cNvPr id="6" name="図形グループ 43"/>
          <p:cNvGrpSpPr/>
          <p:nvPr/>
        </p:nvGrpSpPr>
        <p:grpSpPr>
          <a:xfrm>
            <a:off x="3399551" y="3326021"/>
            <a:ext cx="1025327" cy="369332"/>
            <a:chOff x="5113505" y="907569"/>
            <a:chExt cx="3167420" cy="198119"/>
          </a:xfrm>
        </p:grpSpPr>
        <p:grpSp>
          <p:nvGrpSpPr>
            <p:cNvPr id="7" name="図形グループ 69"/>
            <p:cNvGrpSpPr/>
            <p:nvPr/>
          </p:nvGrpSpPr>
          <p:grpSpPr>
            <a:xfrm>
              <a:off x="5123249" y="907569"/>
              <a:ext cx="3157676" cy="45719"/>
              <a:chOff x="5123249" y="907569"/>
              <a:chExt cx="3157676" cy="45719"/>
            </a:xfrm>
          </p:grpSpPr>
          <p:cxnSp>
            <p:nvCxnSpPr>
              <p:cNvPr id="12" name="直線コネクタ 11"/>
              <p:cNvCxnSpPr/>
              <p:nvPr/>
            </p:nvCxnSpPr>
            <p:spPr>
              <a:xfrm rot="5400000" flipH="1" flipV="1">
                <a:off x="5101281" y="929733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コネクタ 12"/>
              <p:cNvCxnSpPr/>
              <p:nvPr/>
            </p:nvCxnSpPr>
            <p:spPr>
              <a:xfrm flipV="1">
                <a:off x="5124042" y="907569"/>
                <a:ext cx="3155294" cy="9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直線コネクタ 13"/>
              <p:cNvCxnSpPr/>
              <p:nvPr/>
            </p:nvCxnSpPr>
            <p:spPr>
              <a:xfrm rot="5400000" flipH="1" flipV="1">
                <a:off x="8257369" y="929537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図形グループ 68"/>
            <p:cNvGrpSpPr/>
            <p:nvPr/>
          </p:nvGrpSpPr>
          <p:grpSpPr>
            <a:xfrm>
              <a:off x="5113505" y="1059969"/>
              <a:ext cx="1588756" cy="45719"/>
              <a:chOff x="5113505" y="1059969"/>
              <a:chExt cx="1588756" cy="45719"/>
            </a:xfrm>
          </p:grpSpPr>
          <p:cxnSp>
            <p:nvCxnSpPr>
              <p:cNvPr id="9" name="直線コネクタ 8"/>
              <p:cNvCxnSpPr/>
              <p:nvPr/>
            </p:nvCxnSpPr>
            <p:spPr>
              <a:xfrm rot="5400000" flipH="1" flipV="1">
                <a:off x="5091537" y="1082133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直線コネクタ 9"/>
              <p:cNvCxnSpPr/>
              <p:nvPr/>
            </p:nvCxnSpPr>
            <p:spPr>
              <a:xfrm flipV="1">
                <a:off x="5114298" y="1059969"/>
                <a:ext cx="1587963" cy="9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直線コネクタ 10"/>
              <p:cNvCxnSpPr/>
              <p:nvPr/>
            </p:nvCxnSpPr>
            <p:spPr>
              <a:xfrm rot="5400000" flipH="1" flipV="1">
                <a:off x="6670599" y="1082084"/>
                <a:ext cx="45425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5" name="テキスト ボックス 14"/>
          <p:cNvSpPr txBox="1"/>
          <p:nvPr/>
        </p:nvSpPr>
        <p:spPr>
          <a:xfrm>
            <a:off x="1958042" y="4641763"/>
            <a:ext cx="64847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Helvetica"/>
                <a:cs typeface="Helvetica"/>
              </a:rPr>
              <a:t>SA (</a:t>
            </a:r>
            <a:r>
              <a:rPr kumimoji="1" lang="en-US" altLang="ja-JP" sz="900" b="1" dirty="0" err="1" smtClean="0">
                <a:latin typeface="Helvetica"/>
                <a:cs typeface="Helvetica"/>
              </a:rPr>
              <a:t>mM</a:t>
            </a:r>
            <a:r>
              <a:rPr kumimoji="1" lang="en-US" altLang="ja-JP" sz="900" b="1" dirty="0" smtClean="0">
                <a:latin typeface="Helvetica"/>
                <a:cs typeface="Helvetica"/>
              </a:rPr>
              <a:t>)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908004" y="4769853"/>
            <a:ext cx="7020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AB</a:t>
            </a:r>
            <a:r>
              <a:rPr kumimoji="1" lang="en-US" altLang="ja-JP" sz="900" b="1" dirty="0" smtClean="0">
                <a:latin typeface="Helvetica"/>
                <a:cs typeface="Helvetica"/>
              </a:rPr>
              <a:t>A (µM)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3383062" y="5254038"/>
            <a:ext cx="8810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+Bay11-7082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 rot="16200000">
            <a:off x="3948757" y="5194385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+</a:t>
            </a:r>
            <a:r>
              <a:rPr lang="en-US" altLang="ja-JP" sz="900" b="1" dirty="0" err="1" smtClean="0">
                <a:latin typeface="Helvetica"/>
                <a:cs typeface="Helvetica"/>
              </a:rPr>
              <a:t>Vanadate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 rot="16200000">
            <a:off x="1750965" y="3804876"/>
            <a:ext cx="6935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i="1" dirty="0" smtClean="0">
                <a:latin typeface="Helvetica"/>
                <a:cs typeface="Helvetica"/>
              </a:rPr>
              <a:t>WRKY45</a:t>
            </a:r>
            <a:endParaRPr kumimoji="1" lang="ja-JP" altLang="en-US" sz="900" b="1" i="1" dirty="0">
              <a:latin typeface="Helvetica"/>
              <a:cs typeface="Helvetica"/>
            </a:endParaRPr>
          </a:p>
        </p:txBody>
      </p:sp>
      <p:grpSp>
        <p:nvGrpSpPr>
          <p:cNvPr id="20" name="図形グループ 66"/>
          <p:cNvGrpSpPr/>
          <p:nvPr/>
        </p:nvGrpSpPr>
        <p:grpSpPr>
          <a:xfrm>
            <a:off x="3196348" y="2784723"/>
            <a:ext cx="990299" cy="369332"/>
            <a:chOff x="5113505" y="907569"/>
            <a:chExt cx="3167420" cy="198119"/>
          </a:xfrm>
        </p:grpSpPr>
        <p:grpSp>
          <p:nvGrpSpPr>
            <p:cNvPr id="21" name="図形グループ 69"/>
            <p:cNvGrpSpPr/>
            <p:nvPr/>
          </p:nvGrpSpPr>
          <p:grpSpPr>
            <a:xfrm>
              <a:off x="5123249" y="907569"/>
              <a:ext cx="3157676" cy="45719"/>
              <a:chOff x="5123249" y="907569"/>
              <a:chExt cx="3157676" cy="45719"/>
            </a:xfrm>
          </p:grpSpPr>
          <p:cxnSp>
            <p:nvCxnSpPr>
              <p:cNvPr id="26" name="直線コネクタ 25"/>
              <p:cNvCxnSpPr/>
              <p:nvPr/>
            </p:nvCxnSpPr>
            <p:spPr>
              <a:xfrm rot="5400000" flipH="1" flipV="1">
                <a:off x="5101281" y="929733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線コネクタ 26"/>
              <p:cNvCxnSpPr/>
              <p:nvPr/>
            </p:nvCxnSpPr>
            <p:spPr>
              <a:xfrm flipV="1">
                <a:off x="5124042" y="907569"/>
                <a:ext cx="3155294" cy="9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線コネクタ 27"/>
              <p:cNvCxnSpPr/>
              <p:nvPr/>
            </p:nvCxnSpPr>
            <p:spPr>
              <a:xfrm rot="5400000" flipH="1" flipV="1">
                <a:off x="8257369" y="929537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図形グループ 68"/>
            <p:cNvGrpSpPr/>
            <p:nvPr/>
          </p:nvGrpSpPr>
          <p:grpSpPr>
            <a:xfrm>
              <a:off x="5113505" y="1059969"/>
              <a:ext cx="1588756" cy="45719"/>
              <a:chOff x="5113505" y="1059969"/>
              <a:chExt cx="1588756" cy="45719"/>
            </a:xfrm>
          </p:grpSpPr>
          <p:cxnSp>
            <p:nvCxnSpPr>
              <p:cNvPr id="23" name="直線コネクタ 22"/>
              <p:cNvCxnSpPr/>
              <p:nvPr/>
            </p:nvCxnSpPr>
            <p:spPr>
              <a:xfrm rot="5400000" flipH="1" flipV="1">
                <a:off x="5091537" y="1082133"/>
                <a:ext cx="45523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直線コネクタ 23"/>
              <p:cNvCxnSpPr/>
              <p:nvPr/>
            </p:nvCxnSpPr>
            <p:spPr>
              <a:xfrm flipV="1">
                <a:off x="5114298" y="1059969"/>
                <a:ext cx="1587963" cy="9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線コネクタ 24"/>
              <p:cNvCxnSpPr/>
              <p:nvPr/>
            </p:nvCxnSpPr>
            <p:spPr>
              <a:xfrm rot="5400000" flipH="1" flipV="1">
                <a:off x="6670599" y="1082084"/>
                <a:ext cx="45425" cy="1588"/>
              </a:xfrm>
              <a:prstGeom prst="line">
                <a:avLst/>
              </a:prstGeom>
              <a:ln w="635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9" name="テキスト ボックス 28"/>
          <p:cNvSpPr txBox="1"/>
          <p:nvPr/>
        </p:nvSpPr>
        <p:spPr>
          <a:xfrm>
            <a:off x="3503537" y="3423586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**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512184" y="2558342"/>
            <a:ext cx="312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**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734434" y="3142542"/>
            <a:ext cx="364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Helvetica"/>
                <a:cs typeface="Helvetica"/>
              </a:rPr>
              <a:t>**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32" name="直線コネクタ 31"/>
          <p:cNvCxnSpPr/>
          <p:nvPr/>
        </p:nvCxnSpPr>
        <p:spPr>
          <a:xfrm>
            <a:off x="3605225" y="4993530"/>
            <a:ext cx="411667" cy="1588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/>
          <p:cNvCxnSpPr/>
          <p:nvPr/>
        </p:nvCxnSpPr>
        <p:spPr>
          <a:xfrm>
            <a:off x="4135854" y="4995118"/>
            <a:ext cx="411667" cy="1588"/>
          </a:xfrm>
          <a:prstGeom prst="line">
            <a:avLst/>
          </a:prstGeom>
          <a:ln w="9525" cap="flat" cmpd="sng" algn="ctr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/>
          <p:nvPr/>
        </p:nvSpPr>
        <p:spPr>
          <a:xfrm>
            <a:off x="2570512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b="1" dirty="0" smtClean="0">
                <a:latin typeface="Helvetica"/>
                <a:cs typeface="Helvetica"/>
              </a:rPr>
              <a:t>0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2792762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3059462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571027" y="4789369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b="1" dirty="0" smtClean="0">
                <a:latin typeface="Helvetica"/>
                <a:cs typeface="Helvetica"/>
              </a:rPr>
              <a:t>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805977" y="4789369"/>
            <a:ext cx="2487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034577" y="47893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3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250477" y="478936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10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3315609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3544209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804559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3519324" y="47893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3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3747924" y="478936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10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070110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4317760" y="4632966"/>
            <a:ext cx="24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 smtClean="0">
                <a:latin typeface="Helvetica"/>
                <a:cs typeface="Helvetica"/>
              </a:rPr>
              <a:t>1</a:t>
            </a:r>
            <a:endParaRPr kumimoji="1" lang="ja-JP" altLang="en-US" sz="900" b="1" dirty="0">
              <a:latin typeface="Helvetica"/>
              <a:cs typeface="Helvetica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051575" y="478936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3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286525" y="4789369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 smtClean="0">
                <a:latin typeface="Helvetica"/>
                <a:cs typeface="Helvetica"/>
              </a:rPr>
              <a:t>100</a:t>
            </a:r>
            <a:endParaRPr kumimoji="1" lang="ja-JP" altLang="en-US" sz="800" b="1" dirty="0">
              <a:latin typeface="Helvetica"/>
              <a:cs typeface="Helvetica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1904865" y="5809980"/>
            <a:ext cx="3214637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7 Fig. </a:t>
            </a:r>
            <a:r>
              <a:rPr lang="en-US" altLang="ja-JP" sz="1050" dirty="0" err="1">
                <a:latin typeface="Times New Roman"/>
                <a:cs typeface="Times New Roman"/>
              </a:rPr>
              <a:t>PTPase</a:t>
            </a:r>
            <a:r>
              <a:rPr lang="en-US" altLang="ja-JP" sz="1050" dirty="0">
                <a:latin typeface="Times New Roman"/>
                <a:cs typeface="Times New Roman"/>
              </a:rPr>
              <a:t> inhibitors inhibit the suppression of SA-induced </a:t>
            </a:r>
            <a:r>
              <a:rPr lang="en-US" altLang="ja-JP" sz="1050" i="1" dirty="0">
                <a:latin typeface="Times New Roman"/>
                <a:cs typeface="Times New Roman"/>
              </a:rPr>
              <a:t>WRKY45</a:t>
            </a:r>
            <a:r>
              <a:rPr lang="en-US" altLang="ja-JP" sz="1050" dirty="0">
                <a:latin typeface="Times New Roman"/>
                <a:cs typeface="Times New Roman"/>
              </a:rPr>
              <a:t> transcription by ABA. WT rice plants were treated with 1 mM SA and increasing concentrations of ABA, in the presence or absence of 2 mM vanadate or 50 µM Bay11-7082. *, </a:t>
            </a:r>
            <a:r>
              <a:rPr lang="en-US" altLang="ja-JP" sz="1050" i="1" dirty="0">
                <a:latin typeface="Times New Roman"/>
                <a:cs typeface="Times New Roman"/>
              </a:rPr>
              <a:t>P</a:t>
            </a:r>
            <a:r>
              <a:rPr lang="en-US" altLang="ja-JP" sz="1050" dirty="0">
                <a:latin typeface="Times New Roman"/>
                <a:cs typeface="Times New Roman"/>
              </a:rPr>
              <a:t>&lt;0.05; **, </a:t>
            </a:r>
            <a:r>
              <a:rPr lang="en-US" altLang="ja-JP" sz="1050" i="1" dirty="0">
                <a:latin typeface="Times New Roman"/>
                <a:cs typeface="Times New Roman"/>
              </a:rPr>
              <a:t>P</a:t>
            </a:r>
            <a:r>
              <a:rPr lang="en-US" altLang="ja-JP" sz="1050" dirty="0">
                <a:latin typeface="Times New Roman"/>
                <a:cs typeface="Times New Roman"/>
              </a:rPr>
              <a:t>&lt;0.001 (Student’s </a:t>
            </a:r>
            <a:r>
              <a:rPr lang="en-US" altLang="ja-JP" sz="1050" i="1" dirty="0">
                <a:latin typeface="Times New Roman"/>
                <a:cs typeface="Times New Roman"/>
              </a:rPr>
              <a:t>t</a:t>
            </a:r>
            <a:r>
              <a:rPr lang="en-US" altLang="ja-JP" sz="1050" dirty="0">
                <a:latin typeface="Times New Roman"/>
                <a:cs typeface="Times New Roman"/>
              </a:rPr>
              <a:t>-test)</a:t>
            </a:r>
            <a:r>
              <a:rPr lang="en-US" altLang="ja-JP" sz="1050" dirty="0" smtClean="0">
                <a:latin typeface="Times New Roman"/>
                <a:cs typeface="Times New Roman"/>
              </a:rPr>
              <a:t>.</a:t>
            </a:r>
            <a:endParaRPr lang="ja-JP" altLang="ja-JP" sz="105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1080335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105</Words>
  <Application>Microsoft Macintosh PowerPoint</Application>
  <PresentationFormat>画面に合わせる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4:28Z</dcterms:created>
  <dcterms:modified xsi:type="dcterms:W3CDTF">2015-09-28T01:14:53Z</dcterms:modified>
</cp:coreProperties>
</file>